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15.wmf" ContentType="image/x-wmf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667500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51679-AEED-406A-8E01-28605CA790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CE2D4-ED92-45FA-A085-8A22EEBF48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D92FC-BA2F-4C9C-9098-6FF75DBAFB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3706A-C231-4E45-B461-B4E13FD151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50D15-DC9C-4B34-953B-1881E48F0F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1173D-3408-4E84-9BAE-C517E7DF1F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90F1B-42EC-4DCF-9377-90FACA8A8B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C8494-B092-4D59-9D42-0E22B55CCF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D988C-07F9-405F-B454-0DE079C62C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F9CFA-8E9F-4DF4-85DD-BA4936185A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2E769-89A6-463F-B45A-7F571755B3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DD52F-425A-45C8-B2D5-828F8D2A0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81B7F3-569D-42AF-8541-EDF3F36855A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" descr=""/>
          <p:cNvPicPr/>
          <p:nvPr/>
        </p:nvPicPr>
        <p:blipFill>
          <a:blip r:embed="rId1"/>
          <a:srcRect l="21079" t="9544" r="4915" b="21211"/>
          <a:stretch/>
        </p:blipFill>
        <p:spPr>
          <a:xfrm>
            <a:off x="4786200" y="2506680"/>
            <a:ext cx="936720" cy="9129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"/>
          <p:cNvPicPr/>
          <p:nvPr/>
        </p:nvPicPr>
        <p:blipFill>
          <a:blip r:embed="rId2"/>
          <a:srcRect l="23382" t="9604" r="4938" b="21226"/>
          <a:stretch/>
        </p:blipFill>
        <p:spPr>
          <a:xfrm>
            <a:off x="3738600" y="2514600"/>
            <a:ext cx="904680" cy="909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rcRect l="23382" t="8290" r="4707" b="21285"/>
          <a:stretch/>
        </p:blipFill>
        <p:spPr>
          <a:xfrm>
            <a:off x="4819680" y="3484440"/>
            <a:ext cx="915840" cy="9334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"/>
          <p:cNvPicPr/>
          <p:nvPr/>
        </p:nvPicPr>
        <p:blipFill>
          <a:blip r:embed="rId4"/>
          <a:srcRect l="21918" t="8528" r="5254" b="21285"/>
          <a:stretch/>
        </p:blipFill>
        <p:spPr>
          <a:xfrm>
            <a:off x="3724200" y="3487680"/>
            <a:ext cx="924120" cy="927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3" descr=""/>
          <p:cNvPicPr/>
          <p:nvPr/>
        </p:nvPicPr>
        <p:blipFill>
          <a:blip r:embed="rId5"/>
          <a:srcRect l="24019" t="12247" r="4008" b="20941"/>
          <a:stretch/>
        </p:blipFill>
        <p:spPr>
          <a:xfrm>
            <a:off x="4807080" y="1514520"/>
            <a:ext cx="934920" cy="9018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6"/>
          <a:srcRect l="24019" t="10877" r="4309" b="20832"/>
          <a:stretch/>
        </p:blipFill>
        <p:spPr>
          <a:xfrm>
            <a:off x="3726000" y="1495440"/>
            <a:ext cx="923760" cy="9316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4" descr=""/>
          <p:cNvPicPr/>
          <p:nvPr/>
        </p:nvPicPr>
        <p:blipFill>
          <a:blip r:embed="rId7"/>
          <a:srcRect l="24101" t="11261" r="4347" b="20745"/>
          <a:stretch/>
        </p:blipFill>
        <p:spPr>
          <a:xfrm>
            <a:off x="566640" y="2505240"/>
            <a:ext cx="941400" cy="920520"/>
          </a:xfrm>
          <a:prstGeom prst="rect">
            <a:avLst/>
          </a:prstGeom>
          <a:ln w="0">
            <a:noFill/>
          </a:ln>
        </p:spPr>
      </p:pic>
      <p:sp>
        <p:nvSpPr>
          <p:cNvPr id="48" name="textruta 3"/>
          <p:cNvSpPr/>
          <p:nvPr/>
        </p:nvSpPr>
        <p:spPr>
          <a:xfrm>
            <a:off x="260280" y="469800"/>
            <a:ext cx="302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ruta 4"/>
          <p:cNvSpPr/>
          <p:nvPr/>
        </p:nvSpPr>
        <p:spPr>
          <a:xfrm>
            <a:off x="404640" y="5313240"/>
            <a:ext cx="6193080" cy="256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Gating strategy for CD25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27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low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and FOXP3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5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. C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5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neg/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27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non-Tregs), C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5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27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low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(Tregs) and remaining mononuclear cells from cord or adult peripheral blood were sorted using flow cytometry. Next, non-Tregs were stained with CellTrace violet before they were co-cultured with Tregs and the remaining mononuclear cells in the presence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aure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. paracase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or 3-4 days. To set the gate for CD25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27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low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or FOXP3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5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within the CellTrace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on-Treg population (top row) after bacterial stimulation, we compared the expression of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D25 against CD127 or FOXP3 within the total 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 population (middle row) and the CellTrace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ne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e-existing Tregs (bottom row) and set the gate according to the observed population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dot plots shows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aure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timulated cells on one experiment of four performed on cord blood from four different infant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ruta 7"/>
          <p:cNvSpPr/>
          <p:nvPr/>
        </p:nvSpPr>
        <p:spPr>
          <a:xfrm>
            <a:off x="1406520" y="2649600"/>
            <a:ext cx="155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Total 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T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ktangel 22"/>
          <p:cNvSpPr/>
          <p:nvPr/>
        </p:nvSpPr>
        <p:spPr>
          <a:xfrm>
            <a:off x="585720" y="2519280"/>
            <a:ext cx="885960" cy="885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ruta 29"/>
          <p:cNvSpPr/>
          <p:nvPr/>
        </p:nvSpPr>
        <p:spPr>
          <a:xfrm>
            <a:off x="1492200" y="3824280"/>
            <a:ext cx="100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Pre-exist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Tre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ruta 30"/>
          <p:cNvSpPr/>
          <p:nvPr/>
        </p:nvSpPr>
        <p:spPr>
          <a:xfrm>
            <a:off x="1492200" y="1695600"/>
            <a:ext cx="155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Non-Tre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ruta 37"/>
          <p:cNvSpPr/>
          <p:nvPr/>
        </p:nvSpPr>
        <p:spPr>
          <a:xfrm>
            <a:off x="493560" y="3375000"/>
            <a:ext cx="129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ruta 38"/>
          <p:cNvSpPr/>
          <p:nvPr/>
        </p:nvSpPr>
        <p:spPr>
          <a:xfrm rot="16200000">
            <a:off x="-60480" y="2827800"/>
            <a:ext cx="116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ellTrace violet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ruta 39"/>
          <p:cNvSpPr/>
          <p:nvPr/>
        </p:nvSpPr>
        <p:spPr>
          <a:xfrm>
            <a:off x="2573280" y="4386240"/>
            <a:ext cx="129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D12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ruta 40"/>
          <p:cNvSpPr/>
          <p:nvPr/>
        </p:nvSpPr>
        <p:spPr>
          <a:xfrm rot="16200000">
            <a:off x="2018880" y="3797640"/>
            <a:ext cx="116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D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ruta 42"/>
          <p:cNvSpPr/>
          <p:nvPr/>
        </p:nvSpPr>
        <p:spPr>
          <a:xfrm>
            <a:off x="3666960" y="4386240"/>
            <a:ext cx="129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FOXP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9" name="Rak pil 24"/>
          <p:cNvCxnSpPr/>
          <p:nvPr/>
        </p:nvCxnSpPr>
        <p:spPr>
          <a:xfrm>
            <a:off x="4177800" y="4501800"/>
            <a:ext cx="12675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lg" type="triangle" w="med"/>
          </a:ln>
        </p:spPr>
      </p:cxnSp>
      <p:cxnSp>
        <p:nvCxnSpPr>
          <p:cNvPr id="60" name="Rak pil 26"/>
          <p:cNvCxnSpPr/>
          <p:nvPr/>
        </p:nvCxnSpPr>
        <p:spPr>
          <a:xfrm flipV="1">
            <a:off x="2599920" y="1920240"/>
            <a:ext cx="1080" cy="216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lg" type="triangle" w="med"/>
          </a:ln>
        </p:spPr>
      </p:cxnSp>
      <p:sp>
        <p:nvSpPr>
          <p:cNvPr id="61" name="textruta 27"/>
          <p:cNvSpPr/>
          <p:nvPr/>
        </p:nvSpPr>
        <p:spPr>
          <a:xfrm>
            <a:off x="4751280" y="963720"/>
            <a:ext cx="1773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25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127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low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T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Höger klammerparentes 28"/>
          <p:cNvSpPr/>
          <p:nvPr/>
        </p:nvSpPr>
        <p:spPr>
          <a:xfrm rot="16200000">
            <a:off x="3494880" y="367200"/>
            <a:ext cx="271440" cy="1987560"/>
          </a:xfrm>
          <a:custGeom>
            <a:avLst/>
            <a:gdLst>
              <a:gd name="textAreaLeft" fmla="*/ 0 w 271440"/>
              <a:gd name="textAreaRight" fmla="*/ 97920 w 271440"/>
              <a:gd name="textAreaTop" fmla="*/ 38520 h 1987560"/>
              <a:gd name="textAreaBottom" fmla="*/ 1949040 h 1987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71"/>
                  <a:pt x="10800" y="1341"/>
                </a:cubicBezTo>
                <a:lnTo>
                  <a:pt x="10800" y="9459"/>
                </a:lnTo>
                <a:cubicBezTo>
                  <a:pt x="10800" y="10130"/>
                  <a:pt x="16200" y="10800"/>
                  <a:pt x="21600" y="10800"/>
                </a:cubicBezTo>
                <a:cubicBezTo>
                  <a:pt x="16200" y="10800"/>
                  <a:pt x="10800" y="11471"/>
                  <a:pt x="10800" y="12141"/>
                </a:cubicBezTo>
                <a:lnTo>
                  <a:pt x="10800" y="20259"/>
                </a:lnTo>
                <a:cubicBezTo>
                  <a:pt x="10800" y="2093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ruta 49"/>
          <p:cNvSpPr/>
          <p:nvPr/>
        </p:nvSpPr>
        <p:spPr>
          <a:xfrm>
            <a:off x="2852640" y="963720"/>
            <a:ext cx="17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T cell popu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upp 34"/>
          <p:cNvGrpSpPr/>
          <p:nvPr/>
        </p:nvGrpSpPr>
        <p:grpSpPr>
          <a:xfrm>
            <a:off x="2660760" y="3497400"/>
            <a:ext cx="3206520" cy="925200"/>
            <a:chOff x="2660760" y="3497400"/>
            <a:chExt cx="3206520" cy="925200"/>
          </a:xfrm>
        </p:grpSpPr>
        <p:grpSp>
          <p:nvGrpSpPr>
            <p:cNvPr id="65" name="Grupp 32"/>
            <p:cNvGrpSpPr/>
            <p:nvPr/>
          </p:nvGrpSpPr>
          <p:grpSpPr>
            <a:xfrm>
              <a:off x="2660760" y="3497400"/>
              <a:ext cx="3048480" cy="925200"/>
              <a:chOff x="2660760" y="3497400"/>
              <a:chExt cx="3048480" cy="925200"/>
            </a:xfrm>
          </p:grpSpPr>
          <p:pic>
            <p:nvPicPr>
              <p:cNvPr id="66" name="Picture 7" descr=""/>
              <p:cNvPicPr/>
              <p:nvPr/>
            </p:nvPicPr>
            <p:blipFill>
              <a:blip r:embed="rId8"/>
              <a:srcRect l="21471" t="9158" r="4622" b="20944"/>
              <a:stretch/>
            </p:blipFill>
            <p:spPr>
              <a:xfrm>
                <a:off x="2660760" y="3497400"/>
                <a:ext cx="935280" cy="92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Rektangel 15"/>
              <p:cNvSpPr/>
              <p:nvPr/>
            </p:nvSpPr>
            <p:spPr>
              <a:xfrm>
                <a:off x="2685960" y="3513240"/>
                <a:ext cx="884160" cy="8841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Rektangel 16"/>
              <p:cNvSpPr/>
              <p:nvPr/>
            </p:nvSpPr>
            <p:spPr>
              <a:xfrm>
                <a:off x="3743640" y="3513240"/>
                <a:ext cx="885960" cy="8856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Rektangel 17"/>
              <p:cNvSpPr/>
              <p:nvPr/>
            </p:nvSpPr>
            <p:spPr>
              <a:xfrm>
                <a:off x="4823280" y="3511440"/>
                <a:ext cx="885960" cy="8841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textruta 53"/>
            <p:cNvSpPr/>
            <p:nvPr/>
          </p:nvSpPr>
          <p:spPr>
            <a:xfrm>
              <a:off x="2673000" y="357516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ruta 56"/>
            <p:cNvSpPr/>
            <p:nvPr/>
          </p:nvSpPr>
          <p:spPr>
            <a:xfrm>
              <a:off x="4365360" y="357048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ruta 59"/>
            <p:cNvSpPr/>
            <p:nvPr/>
          </p:nvSpPr>
          <p:spPr>
            <a:xfrm>
              <a:off x="5435280" y="357012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3" name="Picture 4" descr=""/>
          <p:cNvPicPr/>
          <p:nvPr/>
        </p:nvPicPr>
        <p:blipFill>
          <a:blip r:embed="rId9"/>
          <a:srcRect l="21795" t="8988" r="4014" b="20766"/>
          <a:stretch/>
        </p:blipFill>
        <p:spPr>
          <a:xfrm>
            <a:off x="2654280" y="2496960"/>
            <a:ext cx="952560" cy="930600"/>
          </a:xfrm>
          <a:prstGeom prst="rect">
            <a:avLst/>
          </a:prstGeom>
          <a:ln w="0">
            <a:noFill/>
          </a:ln>
        </p:spPr>
      </p:pic>
      <p:sp>
        <p:nvSpPr>
          <p:cNvPr id="74" name="Rektangel 12"/>
          <p:cNvSpPr/>
          <p:nvPr/>
        </p:nvSpPr>
        <p:spPr>
          <a:xfrm>
            <a:off x="2682720" y="2519280"/>
            <a:ext cx="885960" cy="885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ktangel 13"/>
          <p:cNvSpPr/>
          <p:nvPr/>
        </p:nvSpPr>
        <p:spPr>
          <a:xfrm>
            <a:off x="3741840" y="2519280"/>
            <a:ext cx="885600" cy="885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ktangel 14"/>
          <p:cNvSpPr/>
          <p:nvPr/>
        </p:nvSpPr>
        <p:spPr>
          <a:xfrm>
            <a:off x="4821120" y="2517840"/>
            <a:ext cx="885960" cy="884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ruta 54"/>
          <p:cNvSpPr/>
          <p:nvPr/>
        </p:nvSpPr>
        <p:spPr>
          <a:xfrm>
            <a:off x="2637000" y="25858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ruta 57"/>
          <p:cNvSpPr/>
          <p:nvPr/>
        </p:nvSpPr>
        <p:spPr>
          <a:xfrm>
            <a:off x="4330800" y="25956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ruta 60"/>
          <p:cNvSpPr/>
          <p:nvPr/>
        </p:nvSpPr>
        <p:spPr>
          <a:xfrm>
            <a:off x="5400720" y="25956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9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0" name="Grupp 36"/>
          <p:cNvGrpSpPr/>
          <p:nvPr/>
        </p:nvGrpSpPr>
        <p:grpSpPr>
          <a:xfrm>
            <a:off x="2655720" y="1492200"/>
            <a:ext cx="3191040" cy="939960"/>
            <a:chOff x="2655720" y="1492200"/>
            <a:chExt cx="3191040" cy="939960"/>
          </a:xfrm>
        </p:grpSpPr>
        <p:grpSp>
          <p:nvGrpSpPr>
            <p:cNvPr id="81" name="Grupp 33"/>
            <p:cNvGrpSpPr/>
            <p:nvPr/>
          </p:nvGrpSpPr>
          <p:grpSpPr>
            <a:xfrm>
              <a:off x="2655720" y="1492200"/>
              <a:ext cx="3053160" cy="939960"/>
              <a:chOff x="2655720" y="1492200"/>
              <a:chExt cx="3053160" cy="939960"/>
            </a:xfrm>
          </p:grpSpPr>
          <p:pic>
            <p:nvPicPr>
              <p:cNvPr id="82" name="Picture 10" descr=""/>
              <p:cNvPicPr/>
              <p:nvPr/>
            </p:nvPicPr>
            <p:blipFill>
              <a:blip r:embed="rId10"/>
              <a:srcRect l="21448" t="7956" r="4476" b="20677"/>
              <a:stretch/>
            </p:blipFill>
            <p:spPr>
              <a:xfrm>
                <a:off x="2655720" y="1492200"/>
                <a:ext cx="945360" cy="939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3" name="Rektangel 18"/>
              <p:cNvSpPr/>
              <p:nvPr/>
            </p:nvSpPr>
            <p:spPr>
              <a:xfrm>
                <a:off x="2685600" y="1519200"/>
                <a:ext cx="884160" cy="8845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Rektangel 19"/>
              <p:cNvSpPr/>
              <p:nvPr/>
            </p:nvSpPr>
            <p:spPr>
              <a:xfrm>
                <a:off x="3743280" y="1519200"/>
                <a:ext cx="885960" cy="8845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Rektangel 20"/>
              <p:cNvSpPr/>
              <p:nvPr/>
            </p:nvSpPr>
            <p:spPr>
              <a:xfrm>
                <a:off x="4822920" y="1517400"/>
                <a:ext cx="885960" cy="8845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6" name="textruta 55"/>
            <p:cNvSpPr/>
            <p:nvPr/>
          </p:nvSpPr>
          <p:spPr>
            <a:xfrm>
              <a:off x="2666160" y="158508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ruta 58"/>
            <p:cNvSpPr/>
            <p:nvPr/>
          </p:nvSpPr>
          <p:spPr>
            <a:xfrm>
              <a:off x="4344840" y="159840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ruta 61"/>
            <p:cNvSpPr/>
            <p:nvPr/>
          </p:nvSpPr>
          <p:spPr>
            <a:xfrm>
              <a:off x="5414760" y="1598400"/>
              <a:ext cx="432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89" name="Rak pil 44"/>
          <p:cNvCxnSpPr/>
          <p:nvPr/>
        </p:nvCxnSpPr>
        <p:spPr>
          <a:xfrm>
            <a:off x="1268280" y="2964960"/>
            <a:ext cx="937440" cy="1080"/>
          </a:xfrm>
          <a:prstGeom prst="straightConnector1">
            <a:avLst/>
          </a:prstGeom>
          <a:ln w="12600">
            <a:solidFill>
              <a:srgbClr val="000000"/>
            </a:solidFill>
            <a:prstDash val="dash"/>
            <a:miter/>
            <a:tailEnd len="lg" type="triangle" w="med"/>
          </a:ln>
        </p:spPr>
      </p:cxnSp>
      <p:cxnSp>
        <p:nvCxnSpPr>
          <p:cNvPr id="90" name="Rak pil 68"/>
          <p:cNvCxnSpPr/>
          <p:nvPr/>
        </p:nvCxnSpPr>
        <p:spPr>
          <a:xfrm flipV="1">
            <a:off x="1217160" y="2109600"/>
            <a:ext cx="1112040" cy="505440"/>
          </a:xfrm>
          <a:prstGeom prst="straightConnector1">
            <a:avLst/>
          </a:prstGeom>
          <a:ln w="12600">
            <a:solidFill>
              <a:srgbClr val="000000"/>
            </a:solidFill>
            <a:prstDash val="dash"/>
            <a:miter/>
            <a:tailEnd len="lg" type="triangle" w="med"/>
          </a:ln>
        </p:spPr>
      </p:cxnSp>
      <p:cxnSp>
        <p:nvCxnSpPr>
          <p:cNvPr id="91" name="Rak pil 70"/>
          <p:cNvCxnSpPr/>
          <p:nvPr/>
        </p:nvCxnSpPr>
        <p:spPr>
          <a:xfrm>
            <a:off x="1217520" y="3198960"/>
            <a:ext cx="1186560" cy="714960"/>
          </a:xfrm>
          <a:prstGeom prst="straightConnector1">
            <a:avLst/>
          </a:prstGeom>
          <a:ln w="12600">
            <a:solidFill>
              <a:srgbClr val="000000"/>
            </a:solidFill>
            <a:prstDash val="dash"/>
            <a:miter/>
            <a:tailEnd len="lg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ruta 3"/>
          <p:cNvSpPr/>
          <p:nvPr/>
        </p:nvSpPr>
        <p:spPr>
          <a:xfrm>
            <a:off x="235080" y="1346040"/>
            <a:ext cx="30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ruta 4"/>
          <p:cNvSpPr/>
          <p:nvPr/>
        </p:nvSpPr>
        <p:spPr>
          <a:xfrm>
            <a:off x="438120" y="5024520"/>
            <a:ext cx="6192720" cy="134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.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aure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timulation of pre-existing Tregs and non-Tregs in the absence of APC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ve dot plots of the proportion of CD25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27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low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within the CellTrace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on-Treg population after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aureu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imulation of C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non-Tregs and autologous Tregs for 3-4 days. The dot plots represent one experiment of two performed on cord blood from three different infants. For each sample 3.000-20.000 CellTrace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4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 cells were collect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4" name="Grupp 8"/>
          <p:cNvGrpSpPr/>
          <p:nvPr/>
        </p:nvGrpSpPr>
        <p:grpSpPr>
          <a:xfrm>
            <a:off x="2384280" y="2487600"/>
            <a:ext cx="2819520" cy="2161080"/>
            <a:chOff x="2384280" y="2487600"/>
            <a:chExt cx="2819520" cy="2161080"/>
          </a:xfrm>
        </p:grpSpPr>
        <p:grpSp>
          <p:nvGrpSpPr>
            <p:cNvPr id="95" name="Grupp 28"/>
            <p:cNvGrpSpPr/>
            <p:nvPr/>
          </p:nvGrpSpPr>
          <p:grpSpPr>
            <a:xfrm>
              <a:off x="2384280" y="2660040"/>
              <a:ext cx="2819520" cy="1988640"/>
              <a:chOff x="2384280" y="2660040"/>
              <a:chExt cx="2819520" cy="1988640"/>
            </a:xfrm>
          </p:grpSpPr>
          <p:grpSp>
            <p:nvGrpSpPr>
              <p:cNvPr id="96" name="Grupp 26"/>
              <p:cNvGrpSpPr/>
              <p:nvPr/>
            </p:nvGrpSpPr>
            <p:grpSpPr>
              <a:xfrm>
                <a:off x="2538720" y="2660040"/>
                <a:ext cx="2665080" cy="1818360"/>
                <a:chOff x="2538720" y="2660040"/>
                <a:chExt cx="2665080" cy="1818360"/>
              </a:xfrm>
            </p:grpSpPr>
            <p:pic>
              <p:nvPicPr>
                <p:cNvPr id="97" name="Picture 356" descr=""/>
                <p:cNvPicPr/>
                <p:nvPr/>
              </p:nvPicPr>
              <p:blipFill>
                <a:blip r:embed="rId1">
                  <a:grayscl/>
                </a:blip>
                <a:srcRect l="24184" t="10347" r="3677" b="20687"/>
                <a:stretch/>
              </p:blipFill>
              <p:spPr>
                <a:xfrm>
                  <a:off x="3350160" y="3673440"/>
                  <a:ext cx="764280" cy="804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8" name="Picture 355" descr=""/>
                <p:cNvPicPr/>
                <p:nvPr/>
              </p:nvPicPr>
              <p:blipFill>
                <a:blip r:embed="rId2">
                  <a:grayscl/>
                </a:blip>
                <a:srcRect l="24184" t="11486" r="3489" b="20644"/>
                <a:stretch/>
              </p:blipFill>
              <p:spPr>
                <a:xfrm>
                  <a:off x="3349080" y="2877480"/>
                  <a:ext cx="776160" cy="777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9" name="textruta 139"/>
                <p:cNvSpPr/>
                <p:nvPr/>
              </p:nvSpPr>
              <p:spPr>
                <a:xfrm>
                  <a:off x="4154400" y="3155760"/>
                  <a:ext cx="1049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unstim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textruta 140"/>
                <p:cNvSpPr/>
                <p:nvPr/>
              </p:nvSpPr>
              <p:spPr>
                <a:xfrm>
                  <a:off x="4154400" y="3993480"/>
                  <a:ext cx="1016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S. aureus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textruta 142"/>
                <p:cNvSpPr/>
                <p:nvPr/>
              </p:nvSpPr>
              <p:spPr>
                <a:xfrm>
                  <a:off x="2688120" y="2660040"/>
                  <a:ext cx="1049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ay 3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textruta 143"/>
                <p:cNvSpPr/>
                <p:nvPr/>
              </p:nvSpPr>
              <p:spPr>
                <a:xfrm>
                  <a:off x="3461400" y="2660040"/>
                  <a:ext cx="1016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ay 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03" name="Grupp 11"/>
                <p:cNvGrpSpPr/>
                <p:nvPr/>
              </p:nvGrpSpPr>
              <p:grpSpPr>
                <a:xfrm>
                  <a:off x="2538720" y="2859120"/>
                  <a:ext cx="1547280" cy="1619280"/>
                  <a:chOff x="2538720" y="2859120"/>
                  <a:chExt cx="1547280" cy="1619280"/>
                </a:xfrm>
              </p:grpSpPr>
              <p:pic>
                <p:nvPicPr>
                  <p:cNvPr id="104" name="Picture 354" descr=""/>
                  <p:cNvPicPr/>
                  <p:nvPr/>
                </p:nvPicPr>
                <p:blipFill>
                  <a:blip r:embed="rId3">
                    <a:grayscl/>
                  </a:blip>
                  <a:srcRect l="24214" t="11377" r="3647" b="20158"/>
                  <a:stretch/>
                </p:blipFill>
                <p:spPr>
                  <a:xfrm>
                    <a:off x="2557800" y="3680280"/>
                    <a:ext cx="759960" cy="79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grpSp>
                <p:nvGrpSpPr>
                  <p:cNvPr id="105" name="Grupp 10"/>
                  <p:cNvGrpSpPr/>
                  <p:nvPr/>
                </p:nvGrpSpPr>
                <p:grpSpPr>
                  <a:xfrm>
                    <a:off x="2539080" y="2859120"/>
                    <a:ext cx="1546920" cy="1599120"/>
                    <a:chOff x="2539080" y="2859120"/>
                    <a:chExt cx="1546920" cy="1599120"/>
                  </a:xfrm>
                </p:grpSpPr>
                <p:pic>
                  <p:nvPicPr>
                    <p:cNvPr id="106" name="Picture 352" descr=""/>
                    <p:cNvPicPr/>
                    <p:nvPr/>
                  </p:nvPicPr>
                  <p:blipFill>
                    <a:blip r:embed="rId4">
                      <a:grayscl/>
                    </a:blip>
                    <a:srcRect l="22605" t="10645" r="4339" b="20267"/>
                    <a:stretch/>
                  </p:blipFill>
                  <p:spPr>
                    <a:xfrm>
                      <a:off x="2539080" y="2859120"/>
                      <a:ext cx="783360" cy="810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07" name="Rektangel 26"/>
                    <p:cNvSpPr/>
                    <p:nvPr/>
                  </p:nvSpPr>
                  <p:spPr>
                    <a:xfrm>
                      <a:off x="2573280" y="2901600"/>
                      <a:ext cx="720720" cy="743400"/>
                    </a:xfrm>
                    <a:prstGeom prst="rect">
                      <a:avLst/>
                    </a:prstGeom>
                    <a:noFill/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08" name="Rektangel 27"/>
                    <p:cNvSpPr/>
                    <p:nvPr/>
                  </p:nvSpPr>
                  <p:spPr>
                    <a:xfrm>
                      <a:off x="2570040" y="3697560"/>
                      <a:ext cx="720720" cy="760680"/>
                    </a:xfrm>
                    <a:prstGeom prst="rect">
                      <a:avLst/>
                    </a:prstGeom>
                    <a:noFill/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09" name="Rektangel 28"/>
                    <p:cNvSpPr/>
                    <p:nvPr/>
                  </p:nvSpPr>
                  <p:spPr>
                    <a:xfrm>
                      <a:off x="3365280" y="2899800"/>
                      <a:ext cx="720720" cy="743400"/>
                    </a:xfrm>
                    <a:prstGeom prst="rect">
                      <a:avLst/>
                    </a:prstGeom>
                    <a:noFill/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10" name="Rektangel 29"/>
                    <p:cNvSpPr/>
                    <p:nvPr/>
                  </p:nvSpPr>
                  <p:spPr>
                    <a:xfrm>
                      <a:off x="3362400" y="3695760"/>
                      <a:ext cx="720720" cy="762480"/>
                    </a:xfrm>
                    <a:prstGeom prst="rect">
                      <a:avLst/>
                    </a:prstGeom>
                    <a:noFill/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111" name="textruta 21"/>
                  <p:cNvSpPr/>
                  <p:nvPr/>
                </p:nvSpPr>
                <p:spPr>
                  <a:xfrm>
                    <a:off x="2538720" y="2898360"/>
                    <a:ext cx="406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2" name="textruta 22"/>
                  <p:cNvSpPr/>
                  <p:nvPr/>
                </p:nvSpPr>
                <p:spPr>
                  <a:xfrm>
                    <a:off x="2538720" y="3708360"/>
                    <a:ext cx="406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textruta 23"/>
                  <p:cNvSpPr/>
                  <p:nvPr/>
                </p:nvSpPr>
                <p:spPr>
                  <a:xfrm>
                    <a:off x="3332160" y="2898360"/>
                    <a:ext cx="406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4" name="textruta 24"/>
                  <p:cNvSpPr/>
                  <p:nvPr/>
                </p:nvSpPr>
                <p:spPr>
                  <a:xfrm>
                    <a:off x="3332160" y="3708360"/>
                    <a:ext cx="406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115" name="textruta 148"/>
              <p:cNvSpPr/>
              <p:nvPr/>
            </p:nvSpPr>
            <p:spPr>
              <a:xfrm>
                <a:off x="2496960" y="4417560"/>
                <a:ext cx="1219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12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16" name="Rak pil 10"/>
              <p:cNvCxnSpPr/>
              <p:nvPr/>
            </p:nvCxnSpPr>
            <p:spPr>
              <a:xfrm flipH="1" flipV="1">
                <a:off x="2496240" y="3158280"/>
                <a:ext cx="1080" cy="9579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117" name="textruta 150"/>
              <p:cNvSpPr/>
              <p:nvPr/>
            </p:nvSpPr>
            <p:spPr>
              <a:xfrm rot="16200000">
                <a:off x="1989360" y="3902760"/>
                <a:ext cx="1020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2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8" name="textruta 156"/>
            <p:cNvSpPr/>
            <p:nvPr/>
          </p:nvSpPr>
          <p:spPr>
            <a:xfrm>
              <a:off x="2755440" y="2487600"/>
              <a:ext cx="122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 APCs presen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9" name="Grupp 2"/>
          <p:cNvGrpSpPr/>
          <p:nvPr/>
        </p:nvGrpSpPr>
        <p:grpSpPr>
          <a:xfrm>
            <a:off x="932040" y="2776680"/>
            <a:ext cx="1895400" cy="1254960"/>
            <a:chOff x="932040" y="2776680"/>
            <a:chExt cx="1895400" cy="1254960"/>
          </a:xfrm>
        </p:grpSpPr>
        <p:pic>
          <p:nvPicPr>
            <p:cNvPr id="120" name="Picture 12" descr=""/>
            <p:cNvPicPr/>
            <p:nvPr/>
          </p:nvPicPr>
          <p:blipFill>
            <a:blip r:embed="rId5"/>
            <a:srcRect l="21980" t="9446" r="3960" b="19074"/>
            <a:stretch/>
          </p:blipFill>
          <p:spPr>
            <a:xfrm>
              <a:off x="1095840" y="3016080"/>
              <a:ext cx="890640" cy="884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Rektangel 32"/>
            <p:cNvSpPr/>
            <p:nvPr/>
          </p:nvSpPr>
          <p:spPr>
            <a:xfrm>
              <a:off x="1130400" y="3044880"/>
              <a:ext cx="809640" cy="809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ruta 77"/>
            <p:cNvSpPr/>
            <p:nvPr/>
          </p:nvSpPr>
          <p:spPr>
            <a:xfrm>
              <a:off x="1031760" y="3800520"/>
              <a:ext cx="129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ruta 78"/>
            <p:cNvSpPr/>
            <p:nvPr/>
          </p:nvSpPr>
          <p:spPr>
            <a:xfrm rot="16200000">
              <a:off x="466560" y="3242160"/>
              <a:ext cx="1162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Trace viole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4" name="Rak pil 35"/>
            <p:cNvCxnSpPr/>
            <p:nvPr/>
          </p:nvCxnSpPr>
          <p:spPr>
            <a:xfrm>
              <a:off x="1846080" y="3241440"/>
              <a:ext cx="36108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prstDash val="dash"/>
              <a:miter/>
              <a:tailEnd len="lg" type="triangle" w="med"/>
            </a:ln>
          </p:spPr>
        </p:cxnSp>
        <p:sp>
          <p:nvSpPr>
            <p:cNvPr id="125" name="textruta 116"/>
            <p:cNvSpPr/>
            <p:nvPr/>
          </p:nvSpPr>
          <p:spPr>
            <a:xfrm>
              <a:off x="1532160" y="3649680"/>
              <a:ext cx="129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eg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ruta 115"/>
            <p:cNvSpPr/>
            <p:nvPr/>
          </p:nvSpPr>
          <p:spPr>
            <a:xfrm>
              <a:off x="1508040" y="2822400"/>
              <a:ext cx="1297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-Treg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0T09:37:24Z</dcterms:created>
  <dc:creator>Hardis Rabe</dc:creator>
  <dc:description/>
  <dc:language>en-US</dc:language>
  <cp:lastModifiedBy>Hardis Rabe</cp:lastModifiedBy>
  <cp:lastPrinted>2013-10-08T07:16:41Z</cp:lastPrinted>
  <dcterms:modified xsi:type="dcterms:W3CDTF">2013-10-17T11:50:22Z</dcterms:modified>
  <cp:revision>48</cp:revision>
  <dc:subject/>
  <dc:title>PowerPoint-presentation</dc:title>
</cp:coreProperties>
</file>